
<file path=[Content_Types].xml><?xml version="1.0" encoding="utf-8"?>
<Types xmlns="http://schemas.openxmlformats.org/package/2006/content-types">
  <Default Extension="xml" ContentType="application/xml"/>
  <Default Extension="jpg" ContentType="image/jpeg"/>
  <Default Extension="tiff" ContentType="image/tiff"/>
  <Default Extension="jpeg" ContentType="image/jpeg"/>
  <Default Extension="rels" ContentType="application/vnd.openxmlformats-package.relationships+xml"/>
  <Default Extension="tif" ContentType="image/tiff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4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75" r:id="rId13"/>
    <p:sldId id="272" r:id="rId14"/>
    <p:sldId id="276" r:id="rId15"/>
    <p:sldId id="268" r:id="rId16"/>
    <p:sldId id="269" r:id="rId17"/>
    <p:sldId id="270" r:id="rId18"/>
    <p:sldId id="271" r:id="rId19"/>
    <p:sldId id="274" r:id="rId20"/>
    <p:sldId id="278" r:id="rId21"/>
    <p:sldId id="279" r:id="rId22"/>
    <p:sldId id="282" r:id="rId23"/>
    <p:sldId id="283" r:id="rId24"/>
    <p:sldId id="284" r:id="rId25"/>
    <p:sldId id="285" r:id="rId26"/>
    <p:sldId id="286" r:id="rId27"/>
    <p:sldId id="287" r:id="rId28"/>
    <p:sldId id="273" r:id="rId29"/>
    <p:sldId id="277" r:id="rId30"/>
    <p:sldId id="280" r:id="rId31"/>
    <p:sldId id="281" r:id="rId32"/>
    <p:sldId id="288" r:id="rId33"/>
    <p:sldId id="289" r:id="rId34"/>
    <p:sldId id="290" r:id="rId35"/>
    <p:sldId id="291" r:id="rId36"/>
    <p:sldId id="292" r:id="rId37"/>
    <p:sldId id="293" r:id="rId38"/>
    <p:sldId id="295" r:id="rId39"/>
    <p:sldId id="296" r:id="rId40"/>
    <p:sldId id="297" r:id="rId41"/>
    <p:sldId id="298" r:id="rId42"/>
    <p:sldId id="299" r:id="rId4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1345" autoAdjust="0"/>
  </p:normalViewPr>
  <p:slideViewPr>
    <p:cSldViewPr snapToGrid="0" snapToObjects="1" showGuides="1">
      <p:cViewPr>
        <p:scale>
          <a:sx n="150" d="100"/>
          <a:sy n="150" d="100"/>
        </p:scale>
        <p:origin x="-328" y="-80"/>
      </p:cViewPr>
      <p:guideLst>
        <p:guide orient="horz" pos="2560"/>
        <p:guide pos="372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46" Type="http://schemas.openxmlformats.org/officeDocument/2006/relationships/presProps" Target="presProps.xml"/><Relationship Id="rId47" Type="http://schemas.openxmlformats.org/officeDocument/2006/relationships/viewProps" Target="viewProps.xml"/><Relationship Id="rId48" Type="http://schemas.openxmlformats.org/officeDocument/2006/relationships/theme" Target="theme/theme1.xml"/><Relationship Id="rId49" Type="http://schemas.openxmlformats.org/officeDocument/2006/relationships/tableStyles" Target="tableStyles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30" Type="http://schemas.openxmlformats.org/officeDocument/2006/relationships/slide" Target="slides/slide29.xml"/><Relationship Id="rId31" Type="http://schemas.openxmlformats.org/officeDocument/2006/relationships/slide" Target="slides/slide30.xml"/><Relationship Id="rId32" Type="http://schemas.openxmlformats.org/officeDocument/2006/relationships/slide" Target="slides/slide31.xml"/><Relationship Id="rId9" Type="http://schemas.openxmlformats.org/officeDocument/2006/relationships/slide" Target="slides/slide8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33" Type="http://schemas.openxmlformats.org/officeDocument/2006/relationships/slide" Target="slides/slide32.xml"/><Relationship Id="rId34" Type="http://schemas.openxmlformats.org/officeDocument/2006/relationships/slide" Target="slides/slide33.xml"/><Relationship Id="rId35" Type="http://schemas.openxmlformats.org/officeDocument/2006/relationships/slide" Target="slides/slide34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37" Type="http://schemas.openxmlformats.org/officeDocument/2006/relationships/slide" Target="slides/slide36.xml"/><Relationship Id="rId38" Type="http://schemas.openxmlformats.org/officeDocument/2006/relationships/slide" Target="slides/slide37.xml"/><Relationship Id="rId39" Type="http://schemas.openxmlformats.org/officeDocument/2006/relationships/slide" Target="slides/slide38.xml"/><Relationship Id="rId40" Type="http://schemas.openxmlformats.org/officeDocument/2006/relationships/slide" Target="slides/slide39.xml"/><Relationship Id="rId41" Type="http://schemas.openxmlformats.org/officeDocument/2006/relationships/slide" Target="slides/slide40.xml"/><Relationship Id="rId42" Type="http://schemas.openxmlformats.org/officeDocument/2006/relationships/slide" Target="slides/slide41.xml"/><Relationship Id="rId43" Type="http://schemas.openxmlformats.org/officeDocument/2006/relationships/slide" Target="slides/slide42.xml"/><Relationship Id="rId44" Type="http://schemas.openxmlformats.org/officeDocument/2006/relationships/notesMaster" Target="notesMasters/notesMaster1.xml"/><Relationship Id="rId45" Type="http://schemas.openxmlformats.org/officeDocument/2006/relationships/printerSettings" Target="printerSettings/printerSettings1.bin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10D682-A97D-4747-BF08-7A75DDFB22B0}" type="datetimeFigureOut">
              <a:rPr lang="en-US" smtClean="0"/>
              <a:t>8/20/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25E426-EAFE-0343-A947-8DCB39FF1B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9836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25E426-EAFE-0343-A947-8DCB39FF1B07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6896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43811-7EFF-3946-A2E5-30BF834FA6C9}" type="datetimeFigureOut">
              <a:rPr lang="en-US" smtClean="0"/>
              <a:t>8/20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409DB-FC86-1848-9404-13A585F24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844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43811-7EFF-3946-A2E5-30BF834FA6C9}" type="datetimeFigureOut">
              <a:rPr lang="en-US" smtClean="0"/>
              <a:t>8/20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409DB-FC86-1848-9404-13A585F24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961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43811-7EFF-3946-A2E5-30BF834FA6C9}" type="datetimeFigureOut">
              <a:rPr lang="en-US" smtClean="0"/>
              <a:t>8/20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409DB-FC86-1848-9404-13A585F24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009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43811-7EFF-3946-A2E5-30BF834FA6C9}" type="datetimeFigureOut">
              <a:rPr lang="en-US" smtClean="0"/>
              <a:t>8/20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409DB-FC86-1848-9404-13A585F24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284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43811-7EFF-3946-A2E5-30BF834FA6C9}" type="datetimeFigureOut">
              <a:rPr lang="en-US" smtClean="0"/>
              <a:t>8/20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409DB-FC86-1848-9404-13A585F24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6881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43811-7EFF-3946-A2E5-30BF834FA6C9}" type="datetimeFigureOut">
              <a:rPr lang="en-US" smtClean="0"/>
              <a:t>8/20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409DB-FC86-1848-9404-13A585F24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041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43811-7EFF-3946-A2E5-30BF834FA6C9}" type="datetimeFigureOut">
              <a:rPr lang="en-US" smtClean="0"/>
              <a:t>8/20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409DB-FC86-1848-9404-13A585F24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234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43811-7EFF-3946-A2E5-30BF834FA6C9}" type="datetimeFigureOut">
              <a:rPr lang="en-US" smtClean="0"/>
              <a:t>8/20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409DB-FC86-1848-9404-13A585F24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514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43811-7EFF-3946-A2E5-30BF834FA6C9}" type="datetimeFigureOut">
              <a:rPr lang="en-US" smtClean="0"/>
              <a:t>8/20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409DB-FC86-1848-9404-13A585F24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039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43811-7EFF-3946-A2E5-30BF834FA6C9}" type="datetimeFigureOut">
              <a:rPr lang="en-US" smtClean="0"/>
              <a:t>8/20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409DB-FC86-1848-9404-13A585F24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403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543811-7EFF-3946-A2E5-30BF834FA6C9}" type="datetimeFigureOut">
              <a:rPr lang="en-US" smtClean="0"/>
              <a:t>8/20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E409DB-FC86-1848-9404-13A585F24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139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543811-7EFF-3946-A2E5-30BF834FA6C9}" type="datetimeFigureOut">
              <a:rPr lang="en-US" smtClean="0"/>
              <a:t>8/20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E409DB-FC86-1848-9404-13A585F24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437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tiff"/><Relationship Id="rId3" Type="http://schemas.openxmlformats.org/officeDocument/2006/relationships/image" Target="../media/image2.tiff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1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2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3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4.png"/><Relationship Id="rId3" Type="http://schemas.openxmlformats.org/officeDocument/2006/relationships/image" Target="../media/image15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6.tif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7.tiff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8.tiff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9.tiff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0.tiff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1.png"/><Relationship Id="rId3" Type="http://schemas.openxmlformats.org/officeDocument/2006/relationships/image" Target="../media/image2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3.pn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4.tif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5.tiff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6.tiff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7.tiff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8.tiff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9.tiff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0.tiff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1.png"/><Relationship Id="rId3" Type="http://schemas.openxmlformats.org/officeDocument/2006/relationships/image" Target="../media/image32.png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3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4.png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4.tif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5.tif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6.tiff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7.tiff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8.tiff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9.tiff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40.tiff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41.tiff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42.jpg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43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5.png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44.jpg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45.jpg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46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8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9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1 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i="1" dirty="0" smtClean="0"/>
              <a:t>PREX1-CPNE1 </a:t>
            </a:r>
            <a:r>
              <a:rPr lang="en-US" dirty="0" smtClean="0"/>
              <a:t>gene fusion in SK-BR-3</a:t>
            </a:r>
            <a:endParaRPr lang="en-US" dirty="0"/>
          </a:p>
        </p:txBody>
      </p:sp>
      <p:pic>
        <p:nvPicPr>
          <p:cNvPr id="3" name="Picture 2" descr="PREX-CPNE1_PREX1_ExonBoundary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73383"/>
            <a:ext cx="9144000" cy="982266"/>
          </a:xfrm>
          <a:prstGeom prst="rect">
            <a:avLst/>
          </a:prstGeom>
        </p:spPr>
      </p:pic>
      <p:pic>
        <p:nvPicPr>
          <p:cNvPr id="4" name="Picture 3" descr="PREX-CPNE1_CPNE1_ExonBoundary.tif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024491"/>
            <a:ext cx="9144000" cy="1840792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>
            <a:off x="4783667" y="2963333"/>
            <a:ext cx="0" cy="1061158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1583647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10 </a:t>
            </a:r>
            <a:r>
              <a:rPr lang="en-US" dirty="0" smtClean="0"/>
              <a:t>chr8</a:t>
            </a:r>
            <a:r>
              <a:rPr lang="en-US" dirty="0"/>
              <a:t>:</a:t>
            </a:r>
            <a:r>
              <a:rPr lang="en-US" dirty="0" smtClean="0"/>
              <a:t>124171162 </a:t>
            </a:r>
            <a:r>
              <a:rPr lang="en-US" dirty="0"/>
              <a:t>SK-BR-3 </a:t>
            </a:r>
            <a:r>
              <a:rPr lang="en-US" dirty="0" smtClean="0"/>
              <a:t>breakpoint</a:t>
            </a:r>
            <a:endParaRPr lang="en-US" dirty="0"/>
          </a:p>
        </p:txBody>
      </p:sp>
      <p:pic>
        <p:nvPicPr>
          <p:cNvPr id="3" name="Picture 2" descr="Breakpoint_WDR67_ZNF704_1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89138"/>
            <a:ext cx="9144000" cy="52705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25636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11 </a:t>
            </a:r>
            <a:r>
              <a:rPr lang="en-US" dirty="0" smtClean="0"/>
              <a:t>chr8</a:t>
            </a:r>
            <a:r>
              <a:rPr lang="en-US" dirty="0"/>
              <a:t>:</a:t>
            </a:r>
            <a:r>
              <a:rPr lang="en-US" dirty="0" smtClean="0"/>
              <a:t>81916434</a:t>
            </a:r>
            <a:r>
              <a:rPr lang="en-US" dirty="0"/>
              <a:t> SK-BR-3 </a:t>
            </a:r>
            <a:r>
              <a:rPr lang="en-US" dirty="0" smtClean="0"/>
              <a:t>breakpoint</a:t>
            </a:r>
            <a:endParaRPr lang="en-US" dirty="0"/>
          </a:p>
        </p:txBody>
      </p:sp>
      <p:pic>
        <p:nvPicPr>
          <p:cNvPr id="3" name="Picture 2" descr="Breakpoint_WDR67_ZNF704_2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83301"/>
            <a:ext cx="9144000" cy="56144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22370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12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A09I copy number alteration</a:t>
            </a:r>
            <a:endParaRPr lang="en-US" dirty="0"/>
          </a:p>
        </p:txBody>
      </p:sp>
      <p:pic>
        <p:nvPicPr>
          <p:cNvPr id="4" name="Picture 3" descr="BRC109.cna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066" y="1529644"/>
            <a:ext cx="7603067" cy="5068711"/>
          </a:xfrm>
          <a:prstGeom prst="rect">
            <a:avLst/>
          </a:prstGeom>
        </p:spPr>
      </p:pic>
      <p:cxnSp>
        <p:nvCxnSpPr>
          <p:cNvPr id="5" name="Straight Arrow Connector 4"/>
          <p:cNvCxnSpPr/>
          <p:nvPr/>
        </p:nvCxnSpPr>
        <p:spPr>
          <a:xfrm flipH="1">
            <a:off x="6502398" y="4220633"/>
            <a:ext cx="152400" cy="1778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2370233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13 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i="1" dirty="0" smtClean="0"/>
              <a:t>NF1-NLE1 </a:t>
            </a:r>
            <a:r>
              <a:rPr lang="en-US" dirty="0" smtClean="0"/>
              <a:t>gene fusion in A09I</a:t>
            </a:r>
            <a:endParaRPr lang="en-US" dirty="0"/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2935817" y="2411413"/>
            <a:ext cx="2118783" cy="706437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452967" y="4427720"/>
            <a:ext cx="823383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Courier"/>
                <a:cs typeface="Courier"/>
              </a:rPr>
              <a:t>Genomic Allele: 17:29506430+55|17:50072973+0|17:50074020+54|17:33464306-</a:t>
            </a:r>
          </a:p>
          <a:p>
            <a:r>
              <a:rPr lang="en-US" sz="1400" i="1" dirty="0" smtClean="0">
                <a:latin typeface="Courier"/>
                <a:cs typeface="Courier"/>
              </a:rPr>
              <a:t>Genes:                    …NF1</a:t>
            </a:r>
            <a:r>
              <a:rPr lang="en-US" sz="1400" dirty="0" smtClean="0">
                <a:latin typeface="Courier"/>
                <a:cs typeface="Courier"/>
              </a:rPr>
              <a:t>|</a:t>
            </a:r>
            <a:r>
              <a:rPr lang="en-US" sz="1400" i="1" dirty="0" smtClean="0">
                <a:latin typeface="Courier"/>
                <a:cs typeface="Courier"/>
              </a:rPr>
              <a:t>CA0</a:t>
            </a:r>
            <a:r>
              <a:rPr lang="en-US" sz="1400" dirty="0" smtClean="0">
                <a:latin typeface="Courier"/>
                <a:cs typeface="Courier"/>
              </a:rPr>
              <a:t>…                    …</a:t>
            </a:r>
            <a:r>
              <a:rPr lang="en-US" sz="1400" i="1" dirty="0" smtClean="0">
                <a:latin typeface="Courier"/>
                <a:cs typeface="Courier"/>
              </a:rPr>
              <a:t>CA0</a:t>
            </a:r>
            <a:r>
              <a:rPr lang="en-US" sz="1400" dirty="0" smtClean="0">
                <a:latin typeface="Courier"/>
                <a:cs typeface="Courier"/>
              </a:rPr>
              <a:t>|</a:t>
            </a:r>
            <a:r>
              <a:rPr lang="en-US" sz="1400" i="1" dirty="0" smtClean="0">
                <a:latin typeface="Courier"/>
                <a:cs typeface="Courier"/>
              </a:rPr>
              <a:t>NLE1…</a:t>
            </a:r>
            <a:endParaRPr lang="en-US" sz="1400" i="1" dirty="0">
              <a:latin typeface="Courier"/>
              <a:cs typeface="Courier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172089"/>
            <a:ext cx="9144000" cy="29077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898017"/>
            <a:ext cx="9144000" cy="513396"/>
          </a:xfrm>
          <a:prstGeom prst="rect">
            <a:avLst/>
          </a:prstGeom>
        </p:spPr>
      </p:pic>
      <p:cxnSp>
        <p:nvCxnSpPr>
          <p:cNvPr id="16" name="Straight Connector 15"/>
          <p:cNvCxnSpPr/>
          <p:nvPr/>
        </p:nvCxnSpPr>
        <p:spPr>
          <a:xfrm>
            <a:off x="5054600" y="3117850"/>
            <a:ext cx="0" cy="4064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2937934" y="2044700"/>
            <a:ext cx="0" cy="366713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2628900" y="2044700"/>
            <a:ext cx="309034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flipH="1">
            <a:off x="4699000" y="3524250"/>
            <a:ext cx="35560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25" name="Table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9344156"/>
              </p:ext>
            </p:extLst>
          </p:nvPr>
        </p:nvGraphicFramePr>
        <p:xfrm>
          <a:off x="330202" y="5131426"/>
          <a:ext cx="8407395" cy="963948"/>
        </p:xfrm>
        <a:graphic>
          <a:graphicData uri="http://schemas.openxmlformats.org/drawingml/2006/table">
            <a:tbl>
              <a:tblPr/>
              <a:tblGrid>
                <a:gridCol w="753529"/>
                <a:gridCol w="846669"/>
                <a:gridCol w="355600"/>
                <a:gridCol w="491065"/>
                <a:gridCol w="372535"/>
                <a:gridCol w="508000"/>
                <a:gridCol w="694267"/>
                <a:gridCol w="677331"/>
                <a:gridCol w="829733"/>
                <a:gridCol w="2878666"/>
              </a:tblGrid>
              <a:tr h="48197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TCGA Sampl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err="1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WashU</a:t>
                      </a:r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 Sampl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Chr1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Pos1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Chr2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Pos2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Sourc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Gene</a:t>
                      </a:r>
                      <a:r>
                        <a:rPr lang="en-US" sz="900" b="1" i="0" u="none" strike="noStrike" baseline="0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 fusion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Self-chain scor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err="1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Genomic_allel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</a:tr>
              <a:tr h="481974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A09I-01A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A09I</a:t>
                      </a:r>
                      <a:endParaRPr lang="en-US" sz="800" b="0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17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29497059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17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33464257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BreakDancer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NF1&gt;NLE1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26.3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17:29506430+55|17:50072973+0|17:50074020+54|17:33464306-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1621587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/>
              <a:t>Figure </a:t>
            </a:r>
            <a:r>
              <a:rPr lang="en-US" dirty="0" smtClean="0"/>
              <a:t>S14 </a:t>
            </a:r>
            <a:r>
              <a:rPr lang="en-US" dirty="0"/>
              <a:t/>
            </a:r>
            <a:br>
              <a:rPr lang="en-US" dirty="0"/>
            </a:br>
            <a:r>
              <a:rPr lang="en-US" dirty="0" smtClean="0"/>
              <a:t>A09I Chr17 copy number alteration</a:t>
            </a:r>
            <a:endParaRPr lang="en-US" dirty="0"/>
          </a:p>
        </p:txBody>
      </p:sp>
      <p:pic>
        <p:nvPicPr>
          <p:cNvPr id="3" name="Picture 2" descr="NF1_NLE1_bk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56864"/>
            <a:ext cx="9144000" cy="411577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6200000">
            <a:off x="26881" y="2463802"/>
            <a:ext cx="15824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Tumor copy – normal copy</a:t>
            </a:r>
            <a:endParaRPr lang="en-US" sz="1000" dirty="0"/>
          </a:p>
        </p:txBody>
      </p:sp>
      <p:sp>
        <p:nvSpPr>
          <p:cNvPr id="5" name="TextBox 4"/>
          <p:cNvSpPr txBox="1"/>
          <p:nvPr/>
        </p:nvSpPr>
        <p:spPr>
          <a:xfrm>
            <a:off x="984250" y="5503474"/>
            <a:ext cx="4951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hr17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10655859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15 </a:t>
            </a:r>
            <a:r>
              <a:rPr lang="en-US" dirty="0" smtClean="0"/>
              <a:t>chr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17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29506430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 </a:t>
            </a:r>
            <a:r>
              <a:rPr lang="en-US" dirty="0" smtClean="0"/>
              <a:t>A09I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>
              <a:solidFill>
                <a:srgbClr val="000000"/>
              </a:solidFill>
            </a:endParaRPr>
          </a:p>
        </p:txBody>
      </p:sp>
      <p:pic>
        <p:nvPicPr>
          <p:cNvPr id="3" name="Picture 2" descr="17-29506430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520" y="1574800"/>
            <a:ext cx="7996980" cy="538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9681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16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chr17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50072973 </a:t>
            </a:r>
            <a:r>
              <a:rPr lang="en-US" dirty="0" smtClean="0"/>
              <a:t>A09I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/>
          </a:p>
        </p:txBody>
      </p:sp>
      <p:pic>
        <p:nvPicPr>
          <p:cNvPr id="3" name="Picture 2" descr="17-50072973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269" y="1555566"/>
            <a:ext cx="7990181" cy="53802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839868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17 </a:t>
            </a:r>
            <a:r>
              <a:rPr lang="en-US" dirty="0" smtClean="0"/>
              <a:t>chr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17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50074020 </a:t>
            </a:r>
            <a:r>
              <a:rPr lang="en-US" dirty="0" smtClean="0"/>
              <a:t>A09I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/>
          </a:p>
        </p:txBody>
      </p:sp>
      <p:pic>
        <p:nvPicPr>
          <p:cNvPr id="3" name="Picture 2" descr="17-50074020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100" y="1564561"/>
            <a:ext cx="7861300" cy="5293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437190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18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chr17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33464306 </a:t>
            </a:r>
            <a:r>
              <a:rPr lang="en-US" dirty="0" smtClean="0"/>
              <a:t>A09I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/>
          </a:p>
        </p:txBody>
      </p:sp>
      <p:pic>
        <p:nvPicPr>
          <p:cNvPr id="4" name="Picture 3" descr="17-33464306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2517" y="1519239"/>
            <a:ext cx="7843736" cy="52816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266211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19 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i="1" dirty="0" smtClean="0"/>
              <a:t>PPP1R1B-PIPOX </a:t>
            </a:r>
            <a:r>
              <a:rPr lang="en-US" dirty="0" smtClean="0"/>
              <a:t>fusion in A0D1</a:t>
            </a:r>
            <a:endParaRPr lang="en-US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8014042"/>
              </p:ext>
            </p:extLst>
          </p:nvPr>
        </p:nvGraphicFramePr>
        <p:xfrm>
          <a:off x="279404" y="4649452"/>
          <a:ext cx="8407395" cy="963948"/>
        </p:xfrm>
        <a:graphic>
          <a:graphicData uri="http://schemas.openxmlformats.org/drawingml/2006/table">
            <a:tbl>
              <a:tblPr/>
              <a:tblGrid>
                <a:gridCol w="753529"/>
                <a:gridCol w="804334"/>
                <a:gridCol w="330200"/>
                <a:gridCol w="558800"/>
                <a:gridCol w="347133"/>
                <a:gridCol w="491067"/>
                <a:gridCol w="626533"/>
                <a:gridCol w="787400"/>
                <a:gridCol w="829733"/>
                <a:gridCol w="2878666"/>
              </a:tblGrid>
              <a:tr h="48197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TCGA Sampl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err="1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WashU</a:t>
                      </a:r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 Sampl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Chr1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Pos1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Chr2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Pos2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Sourc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Gene</a:t>
                      </a:r>
                      <a:r>
                        <a:rPr lang="en-US" sz="900" b="1" i="0" u="none" strike="noStrike" baseline="0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 fusion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Self-chain scor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err="1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Genomic_allel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</a:tr>
              <a:tr h="481974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A0D1-01A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A0D1</a:t>
                      </a:r>
                      <a:endParaRPr lang="en-US" sz="800" b="0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17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27379942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17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37792024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BreakDancer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1" u="none" strike="noStrike" dirty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PPP1R1B&gt;PIPOX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26.3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17:37792878+45|17:37792543-0|17:37792535-5|17:26168287+0|17:26171328+35|17:27378219+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</a:tr>
            </a:tbl>
          </a:graphicData>
        </a:graphic>
      </p:graphicFrame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771132"/>
            <a:ext cx="9144000" cy="29286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960033"/>
            <a:ext cx="9144000" cy="828509"/>
          </a:xfrm>
          <a:prstGeom prst="rect">
            <a:avLst/>
          </a:prstGeom>
        </p:spPr>
      </p:pic>
      <p:cxnSp>
        <p:nvCxnSpPr>
          <p:cNvPr id="8" name="Straight Arrow Connector 7"/>
          <p:cNvCxnSpPr/>
          <p:nvPr/>
        </p:nvCxnSpPr>
        <p:spPr>
          <a:xfrm flipH="1">
            <a:off x="6189133" y="2895600"/>
            <a:ext cx="1930402" cy="8128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8119535" y="1809750"/>
            <a:ext cx="0" cy="108585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6197602" y="3708400"/>
            <a:ext cx="0" cy="460209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7683500" y="1809750"/>
            <a:ext cx="436035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6197602" y="4168609"/>
            <a:ext cx="47624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9551133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2 </a:t>
            </a:r>
            <a:r>
              <a:rPr lang="en-US" dirty="0" smtClean="0"/>
              <a:t>chr20</a:t>
            </a:r>
            <a:r>
              <a:rPr lang="en-US" dirty="0"/>
              <a:t>:</a:t>
            </a:r>
            <a:r>
              <a:rPr lang="en-US" dirty="0" smtClean="0"/>
              <a:t>46795673 SK-BR-3 breakpoint</a:t>
            </a:r>
            <a:endParaRPr lang="en-US" dirty="0"/>
          </a:p>
        </p:txBody>
      </p:sp>
      <p:pic>
        <p:nvPicPr>
          <p:cNvPr id="3" name="Picture 2" descr="Breakpoint_PREX1_PHF20_1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71638"/>
            <a:ext cx="9144000" cy="5402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135542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20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A0D1 copy number alteration</a:t>
            </a:r>
            <a:endParaRPr lang="en-US" dirty="0"/>
          </a:p>
        </p:txBody>
      </p:sp>
      <p:pic>
        <p:nvPicPr>
          <p:cNvPr id="4" name="Picture 3" descr="BRC99.cna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2067" y="1529645"/>
            <a:ext cx="7603066" cy="50687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998850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21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A0D1 chr17 copy number alteration</a:t>
            </a:r>
            <a:endParaRPr lang="en-US" dirty="0"/>
          </a:p>
        </p:txBody>
      </p:sp>
      <p:pic>
        <p:nvPicPr>
          <p:cNvPr id="3" name="Picture 2" descr="chr17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43050"/>
            <a:ext cx="9144000" cy="462410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84250" y="5793660"/>
            <a:ext cx="4951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hr17</a:t>
            </a:r>
            <a:endParaRPr lang="en-US" sz="1000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26881" y="2463802"/>
            <a:ext cx="15824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Tumor copy – normal copy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1508035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22 </a:t>
            </a:r>
            <a:r>
              <a:rPr lang="en-US" dirty="0" smtClean="0"/>
              <a:t>chr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17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37792878 </a:t>
            </a:r>
            <a:r>
              <a:rPr lang="en-US" dirty="0" smtClean="0"/>
              <a:t>A0D1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>
              <a:solidFill>
                <a:srgbClr val="000000"/>
              </a:solidFill>
            </a:endParaRPr>
          </a:p>
        </p:txBody>
      </p:sp>
      <p:pic>
        <p:nvPicPr>
          <p:cNvPr id="4" name="Picture 3" descr="17-37792878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617526"/>
            <a:ext cx="7537450" cy="50753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679287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23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chr17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37792543 </a:t>
            </a:r>
            <a:r>
              <a:rPr lang="en-US" dirty="0" smtClean="0"/>
              <a:t>A0D1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/>
          </a:p>
        </p:txBody>
      </p:sp>
      <p:pic>
        <p:nvPicPr>
          <p:cNvPr id="4" name="Picture 3" descr="17-37792543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4700" y="1608138"/>
            <a:ext cx="7581900" cy="51053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103742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24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chr17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37792543 </a:t>
            </a:r>
            <a:r>
              <a:rPr lang="en-US" dirty="0" smtClean="0"/>
              <a:t>A0D1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/>
          </a:p>
        </p:txBody>
      </p:sp>
      <p:pic>
        <p:nvPicPr>
          <p:cNvPr id="4" name="Picture 3" descr="17-37792535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051" y="1661699"/>
            <a:ext cx="7625706" cy="5134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738660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25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chr17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26168287 </a:t>
            </a:r>
            <a:r>
              <a:rPr lang="en-US" dirty="0" smtClean="0"/>
              <a:t>A0D1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/>
          </a:p>
        </p:txBody>
      </p:sp>
      <p:pic>
        <p:nvPicPr>
          <p:cNvPr id="4" name="Picture 3" descr="17-26168287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9950" y="1652588"/>
            <a:ext cx="7480300" cy="503689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724401" y="5988053"/>
            <a:ext cx="5016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/>
              <a:t>NOS2</a:t>
            </a:r>
            <a:endParaRPr lang="en-US" sz="700" i="1" dirty="0"/>
          </a:p>
        </p:txBody>
      </p:sp>
    </p:spTree>
    <p:extLst>
      <p:ext uri="{BB962C8B-B14F-4D97-AF65-F5344CB8AC3E}">
        <p14:creationId xmlns:p14="http://schemas.microsoft.com/office/powerpoint/2010/main" val="258707196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26 </a:t>
            </a:r>
            <a:r>
              <a:rPr lang="en-US" dirty="0" smtClean="0"/>
              <a:t>chr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17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26171328 </a:t>
            </a:r>
            <a:r>
              <a:rPr lang="en-US" dirty="0" smtClean="0"/>
              <a:t>A0D1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/>
          </a:p>
        </p:txBody>
      </p:sp>
      <p:pic>
        <p:nvPicPr>
          <p:cNvPr id="4" name="Picture 3" descr="17-26171328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6600" y="1639888"/>
            <a:ext cx="7547904" cy="508241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641850" y="6034854"/>
            <a:ext cx="5016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i="1" dirty="0" smtClean="0"/>
              <a:t>NOS2</a:t>
            </a:r>
            <a:endParaRPr lang="en-US" sz="700" i="1" dirty="0"/>
          </a:p>
        </p:txBody>
      </p:sp>
    </p:spTree>
    <p:extLst>
      <p:ext uri="{BB962C8B-B14F-4D97-AF65-F5344CB8AC3E}">
        <p14:creationId xmlns:p14="http://schemas.microsoft.com/office/powerpoint/2010/main" val="209721947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27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chr17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27378219 </a:t>
            </a:r>
            <a:r>
              <a:rPr lang="en-US" dirty="0" smtClean="0"/>
              <a:t>A0D1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/>
          </a:p>
        </p:txBody>
      </p:sp>
      <p:pic>
        <p:nvPicPr>
          <p:cNvPr id="4" name="Picture 3" descr="17-27378219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101" y="1595438"/>
            <a:ext cx="7533760" cy="50728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182089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Figure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S28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/>
            </a:r>
            <a:b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</a:br>
            <a:r>
              <a:rPr lang="en-US" i="1" dirty="0" smtClean="0">
                <a:solidFill>
                  <a:srgbClr val="000000"/>
                </a:solidFill>
                <a:ea typeface="Calibri"/>
                <a:cs typeface="Calibri"/>
              </a:rPr>
              <a:t>PPP3R1-TTC27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fusion in A0YG</a:t>
            </a:r>
            <a:endParaRPr lang="en-US" dirty="0">
              <a:solidFill>
                <a:srgbClr val="000000"/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247900"/>
            <a:ext cx="9144000" cy="43116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346450"/>
            <a:ext cx="9144000" cy="358588"/>
          </a:xfrm>
          <a:prstGeom prst="rect">
            <a:avLst/>
          </a:prstGeom>
        </p:spPr>
      </p:pic>
      <p:cxnSp>
        <p:nvCxnSpPr>
          <p:cNvPr id="8" name="Straight Connector 7"/>
          <p:cNvCxnSpPr/>
          <p:nvPr/>
        </p:nvCxnSpPr>
        <p:spPr>
          <a:xfrm>
            <a:off x="8972550" y="2178050"/>
            <a:ext cx="0" cy="6985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7169150" y="3251200"/>
            <a:ext cx="0" cy="62865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H="1">
            <a:off x="7169150" y="2876550"/>
            <a:ext cx="1803400" cy="37465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7169150" y="3879850"/>
            <a:ext cx="42545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H="1">
            <a:off x="8972550" y="2178050"/>
            <a:ext cx="95250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21" name="Table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6749594"/>
              </p:ext>
            </p:extLst>
          </p:nvPr>
        </p:nvGraphicFramePr>
        <p:xfrm>
          <a:off x="330202" y="4758893"/>
          <a:ext cx="8407395" cy="963948"/>
        </p:xfrm>
        <a:graphic>
          <a:graphicData uri="http://schemas.openxmlformats.org/drawingml/2006/table">
            <a:tbl>
              <a:tblPr/>
              <a:tblGrid>
                <a:gridCol w="728131"/>
                <a:gridCol w="872067"/>
                <a:gridCol w="355600"/>
                <a:gridCol w="524933"/>
                <a:gridCol w="338667"/>
                <a:gridCol w="541867"/>
                <a:gridCol w="660400"/>
                <a:gridCol w="821266"/>
                <a:gridCol w="846667"/>
                <a:gridCol w="2717797"/>
              </a:tblGrid>
              <a:tr h="48197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TCGA Sampl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err="1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WashU</a:t>
                      </a:r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 Sampl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Chr1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Pos1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Chr2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Pos2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Sourc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Gene</a:t>
                      </a:r>
                      <a:r>
                        <a:rPr lang="en-US" sz="900" b="1" i="0" u="none" strike="noStrike" baseline="0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 fusion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Self-chain scor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i="0" u="none" strike="noStrike" dirty="0" err="1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Genomic_allele</a:t>
                      </a:r>
                      <a:endParaRPr lang="en-US" sz="900" b="1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</a:tr>
              <a:tr h="481974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A0YG-01A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 smtClean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A0YG</a:t>
                      </a:r>
                      <a:endParaRPr lang="en-US" sz="800" b="0" i="0" u="none" strike="noStrike" dirty="0">
                        <a:solidFill>
                          <a:srgbClr val="006100"/>
                        </a:solidFill>
                        <a:effectLst/>
                        <a:latin typeface="Calibri"/>
                      </a:endParaRP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33007790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68479370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BreakDancer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PPP3R1&gt;TTC27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rgbClr val="006100"/>
                          </a:solidFill>
                          <a:effectLst/>
                          <a:latin typeface="Calibri"/>
                        </a:rPr>
                        <a:t>2:68474379-3|2:61696395-0|2:61648297-3|2:33525486-0|2:33483602-2|2:33006736+</a:t>
                      </a:r>
                    </a:p>
                  </a:txBody>
                  <a:tcPr marL="5644" marR="5644" marT="56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825084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29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A0YG copy number alteration</a:t>
            </a:r>
            <a:endParaRPr lang="en-US" dirty="0"/>
          </a:p>
        </p:txBody>
      </p:sp>
      <p:pic>
        <p:nvPicPr>
          <p:cNvPr id="4" name="Picture 3" descr="BRC100.cna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400" y="1560689"/>
            <a:ext cx="7509933" cy="50066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19463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3 </a:t>
            </a:r>
            <a:r>
              <a:rPr lang="en-US" dirty="0" smtClean="0"/>
              <a:t>chr20</a:t>
            </a:r>
            <a:r>
              <a:rPr lang="en-US" dirty="0"/>
              <a:t>:</a:t>
            </a:r>
            <a:r>
              <a:rPr lang="en-US" dirty="0" smtClean="0"/>
              <a:t>33925625 </a:t>
            </a:r>
            <a:r>
              <a:rPr lang="en-US" dirty="0"/>
              <a:t>SK-BR-3 </a:t>
            </a:r>
            <a:r>
              <a:rPr lang="en-US" dirty="0" smtClean="0"/>
              <a:t>breakpoint</a:t>
            </a:r>
            <a:endParaRPr lang="en-US" dirty="0"/>
          </a:p>
        </p:txBody>
      </p:sp>
      <p:pic>
        <p:nvPicPr>
          <p:cNvPr id="4" name="Picture 3" descr="Breakpoint_PREX1_PHF20_2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78517"/>
            <a:ext cx="9144000" cy="5402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242640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Figure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S30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/>
            </a:r>
            <a:b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</a:b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A0YG Chr2 </a:t>
            </a:r>
            <a:r>
              <a:rPr lang="en-US" dirty="0" err="1" smtClean="0">
                <a:solidFill>
                  <a:srgbClr val="000000"/>
                </a:solidFill>
                <a:ea typeface="Calibri"/>
                <a:cs typeface="Calibri"/>
              </a:rPr>
              <a:t>chromothripsis</a:t>
            </a:r>
            <a:endParaRPr lang="en-US" dirty="0"/>
          </a:p>
        </p:txBody>
      </p:sp>
      <p:pic>
        <p:nvPicPr>
          <p:cNvPr id="3" name="Picture 2" descr="chr2.chromothripsis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39900"/>
            <a:ext cx="9144000" cy="426295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6200000">
            <a:off x="614575" y="2089150"/>
            <a:ext cx="4070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log2</a:t>
            </a:r>
            <a:endParaRPr lang="en-US" sz="1000" dirty="0"/>
          </a:p>
        </p:txBody>
      </p:sp>
      <p:sp>
        <p:nvSpPr>
          <p:cNvPr id="5" name="TextBox 4"/>
          <p:cNvSpPr txBox="1"/>
          <p:nvPr/>
        </p:nvSpPr>
        <p:spPr>
          <a:xfrm>
            <a:off x="984250" y="5607050"/>
            <a:ext cx="4301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hr2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4779254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Figure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S31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/>
            </a:r>
            <a:b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</a:br>
            <a:r>
              <a:rPr lang="en-US" i="1" dirty="0" smtClean="0">
                <a:solidFill>
                  <a:srgbClr val="000000"/>
                </a:solidFill>
                <a:ea typeface="Calibri"/>
                <a:cs typeface="Calibri"/>
              </a:rPr>
              <a:t>PPP3R1-TTC27 </a:t>
            </a:r>
            <a:r>
              <a:rPr lang="en-US" dirty="0" err="1" smtClean="0">
                <a:solidFill>
                  <a:srgbClr val="000000"/>
                </a:solidFill>
                <a:ea typeface="Calibri"/>
                <a:cs typeface="Calibri"/>
              </a:rPr>
              <a:t>chromothripsis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 fusion</a:t>
            </a:r>
            <a:endParaRPr lang="en-US" dirty="0"/>
          </a:p>
        </p:txBody>
      </p:sp>
      <p:pic>
        <p:nvPicPr>
          <p:cNvPr id="3" name="Picture 2" descr="PPP1R1B-PIPOX.cna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14500"/>
            <a:ext cx="9144000" cy="426295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84250" y="5607050"/>
            <a:ext cx="4301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hr2</a:t>
            </a:r>
            <a:endParaRPr lang="en-US" sz="1000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614575" y="2089150"/>
            <a:ext cx="4070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log2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50439703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32 </a:t>
            </a:r>
            <a:r>
              <a:rPr lang="en-US" dirty="0" smtClean="0"/>
              <a:t>chr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2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68474379 </a:t>
            </a:r>
            <a:r>
              <a:rPr lang="en-US" dirty="0" smtClean="0"/>
              <a:t>A0YG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>
              <a:solidFill>
                <a:srgbClr val="000000"/>
              </a:solidFill>
            </a:endParaRPr>
          </a:p>
        </p:txBody>
      </p:sp>
      <p:pic>
        <p:nvPicPr>
          <p:cNvPr id="3" name="Picture 2" descr="2-68474379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400" y="1519899"/>
            <a:ext cx="7556500" cy="5088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760851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33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chr2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61696395 </a:t>
            </a:r>
            <a:r>
              <a:rPr lang="en-US" dirty="0" smtClean="0"/>
              <a:t>A0YG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/>
          </a:p>
        </p:txBody>
      </p:sp>
      <p:pic>
        <p:nvPicPr>
          <p:cNvPr id="3" name="Picture 2" descr="2-61696395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451" y="1582738"/>
            <a:ext cx="7547904" cy="50824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57403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34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chr2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61648297 </a:t>
            </a:r>
            <a:r>
              <a:rPr lang="en-US" dirty="0" smtClean="0"/>
              <a:t>A0YG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/>
          </a:p>
        </p:txBody>
      </p:sp>
      <p:pic>
        <p:nvPicPr>
          <p:cNvPr id="3" name="Picture 2" descr="2-61648297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4700" y="1601788"/>
            <a:ext cx="7547904" cy="50824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741833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35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chr2:33525486 </a:t>
            </a:r>
            <a:r>
              <a:rPr lang="en-US" dirty="0" smtClean="0"/>
              <a:t>A0YG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/>
          </a:p>
        </p:txBody>
      </p:sp>
      <p:pic>
        <p:nvPicPr>
          <p:cNvPr id="3" name="Picture 2" descr="2-33525486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450" y="1555571"/>
            <a:ext cx="7588250" cy="51095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264312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36 </a:t>
            </a:r>
            <a:r>
              <a:rPr lang="en-US" dirty="0" smtClean="0"/>
              <a:t>chr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2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33483602 </a:t>
            </a:r>
            <a:r>
              <a:rPr lang="en-US" dirty="0" smtClean="0"/>
              <a:t>A0YG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/>
          </a:p>
        </p:txBody>
      </p:sp>
      <p:pic>
        <p:nvPicPr>
          <p:cNvPr id="3" name="Picture 2" descr="2-33483602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950" y="1608138"/>
            <a:ext cx="7547904" cy="50824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980611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37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chr2</a:t>
            </a:r>
            <a:r>
              <a:rPr lang="en-US" dirty="0">
                <a:solidFill>
                  <a:srgbClr val="000000"/>
                </a:solidFill>
                <a:ea typeface="Calibri"/>
                <a:cs typeface="Calibri"/>
              </a:rPr>
              <a:t>: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33006736 </a:t>
            </a:r>
            <a:r>
              <a:rPr lang="en-US" dirty="0" smtClean="0"/>
              <a:t>A0YG </a:t>
            </a:r>
            <a:r>
              <a:rPr lang="en-US" dirty="0" smtClean="0">
                <a:solidFill>
                  <a:srgbClr val="000000"/>
                </a:solidFill>
                <a:ea typeface="Calibri"/>
                <a:cs typeface="Calibri"/>
              </a:rPr>
              <a:t>breakpoint</a:t>
            </a:r>
            <a:endParaRPr lang="en-US" dirty="0"/>
          </a:p>
        </p:txBody>
      </p:sp>
      <p:pic>
        <p:nvPicPr>
          <p:cNvPr id="3" name="Picture 2" descr="2-33006736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9300" y="1614488"/>
            <a:ext cx="7547904" cy="50824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376619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38 </a:t>
            </a:r>
            <a:r>
              <a:rPr lang="en-US" dirty="0" smtClean="0"/>
              <a:t>TCGA SV breakpoint validation</a:t>
            </a:r>
            <a:endParaRPr lang="en-US" dirty="0"/>
          </a:p>
        </p:txBody>
      </p:sp>
      <p:pic>
        <p:nvPicPr>
          <p:cNvPr id="3" name="Picture 2" descr="BRC 1_lonza_060513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6999" y="1538182"/>
            <a:ext cx="3657600" cy="2834640"/>
          </a:xfrm>
          <a:prstGeom prst="rect">
            <a:avLst/>
          </a:prstGeom>
        </p:spPr>
      </p:pic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6259205"/>
              </p:ext>
            </p:extLst>
          </p:nvPr>
        </p:nvGraphicFramePr>
        <p:xfrm>
          <a:off x="956733" y="4419177"/>
          <a:ext cx="7306733" cy="2311400"/>
        </p:xfrm>
        <a:graphic>
          <a:graphicData uri="http://schemas.openxmlformats.org/drawingml/2006/table">
            <a:tbl>
              <a:tblPr/>
              <a:tblGrid>
                <a:gridCol w="893909"/>
                <a:gridCol w="1347341"/>
                <a:gridCol w="2396712"/>
                <a:gridCol w="611372"/>
                <a:gridCol w="889000"/>
                <a:gridCol w="1168399"/>
              </a:tblGrid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i="0" u="none" strike="noStrike">
                          <a:effectLst/>
                          <a:latin typeface="Arial"/>
                        </a:rPr>
                        <a:t>Gel 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Gene</a:t>
                      </a:r>
                      <a:r>
                        <a:rPr lang="en-US" sz="1000" b="1" i="0" u="none" strike="noStrike" baseline="0" dirty="0" smtClean="0">
                          <a:effectLst/>
                          <a:latin typeface="Arial"/>
                        </a:rPr>
                        <a:t> Fusion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effectLst/>
                          <a:latin typeface="Arial"/>
                        </a:rPr>
                        <a:t>DNA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Tissue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err="1" smtClean="0">
                          <a:effectLst/>
                          <a:latin typeface="Arial"/>
                        </a:rPr>
                        <a:t>Amplicon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Common </a:t>
                      </a:r>
                      <a:r>
                        <a:rPr lang="en-US" sz="1000" b="1" i="0" u="none" strike="noStrike" dirty="0">
                          <a:effectLst/>
                          <a:latin typeface="Arial"/>
                        </a:rPr>
                        <a:t>na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Ladde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PPP1R1B&gt;PIPO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D1-01A-1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1000" b="0" i="0" u="none" strike="noStrike" dirty="0" err="1" smtClean="0">
                          <a:effectLst/>
                          <a:latin typeface="Arial"/>
                        </a:rPr>
                        <a:t>Tumor</a:t>
                      </a:r>
                      <a:endParaRPr lang="tr-TR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1000" b="0" i="0" u="none" strike="noStrike" dirty="0">
                          <a:effectLst/>
                          <a:latin typeface="Arial"/>
                        </a:rPr>
                        <a:t>H_17_029iy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9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PPP1R1B&gt;PIPO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D1-10A-01D-A04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tr-TR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1000" b="0" i="0" u="none" strike="noStrike" dirty="0">
                          <a:effectLst/>
                          <a:latin typeface="Arial"/>
                        </a:rPr>
                        <a:t>H_17_029iy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9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PPP1R1B&gt;PIPO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D1-01A-1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Tumor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9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PPP1R1B&gt;PIPO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D1-10A-01D-A04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9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PPP1R1B&gt;PIPO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D1-01A-1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Tumor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B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BRC9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PPP1R1B&gt;PIPO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D1-10A-01D-A04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B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9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LPCAT1&gt;CLPTM1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7-A0CE-01A-11D-A12L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Tumor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05_029bO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8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LPCAT1&gt;CLPTM1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7-A0CE-10A-01D-A01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05_029bO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8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UBL3&gt;MTIF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7-A0CE-01A-11D-A12L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Tumor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3_029iv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8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UBL3&gt;MTIF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7-A0CE-10A-01D-A01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3_029iv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8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LAN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LAN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98920783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/>
              <a:t>Figure </a:t>
            </a:r>
            <a:r>
              <a:rPr lang="en-US" dirty="0" smtClean="0"/>
              <a:t>S39 </a:t>
            </a:r>
            <a:r>
              <a:rPr lang="en-US" dirty="0"/>
              <a:t>TCGA SV breakpoint validation</a:t>
            </a:r>
          </a:p>
        </p:txBody>
      </p:sp>
      <p:pic>
        <p:nvPicPr>
          <p:cNvPr id="4" name="Picture 3" descr="BRC 2_lonza_060513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4734" y="1559719"/>
            <a:ext cx="3657600" cy="2834640"/>
          </a:xfrm>
          <a:prstGeom prst="rect">
            <a:avLst/>
          </a:prstGeom>
        </p:spPr>
      </p:pic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1703913"/>
              </p:ext>
            </p:extLst>
          </p:nvPr>
        </p:nvGraphicFramePr>
        <p:xfrm>
          <a:off x="1066800" y="4394359"/>
          <a:ext cx="7044266" cy="2311400"/>
        </p:xfrm>
        <a:graphic>
          <a:graphicData uri="http://schemas.openxmlformats.org/drawingml/2006/table">
            <a:tbl>
              <a:tblPr/>
              <a:tblGrid>
                <a:gridCol w="860273"/>
                <a:gridCol w="1296644"/>
                <a:gridCol w="2160281"/>
                <a:gridCol w="644002"/>
                <a:gridCol w="803014"/>
                <a:gridCol w="1280052"/>
              </a:tblGrid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000" b="1" i="0" u="none" strike="noStrike">
                          <a:effectLst/>
                          <a:latin typeface="Arial"/>
                        </a:rPr>
                        <a:t>Gel 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Gene Fusion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DNA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Tissue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err="1" smtClean="0">
                          <a:effectLst/>
                          <a:latin typeface="Arial"/>
                        </a:rPr>
                        <a:t>Amplicon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Common </a:t>
                      </a:r>
                      <a:r>
                        <a:rPr lang="en-US" sz="1000" b="1" i="0" u="none" strike="noStrike" dirty="0">
                          <a:effectLst/>
                          <a:latin typeface="Arial"/>
                        </a:rPr>
                        <a:t>na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Ladde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PPP3R1&gt;TTC2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YG-01A-21D-A11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Tumor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_02_029i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PPP3R1&gt;TTC2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YG-10A-0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_02_029i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PPP3R1&gt;TTC2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YG-01A-21D-A11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Tumor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02_029ip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PPP3R1&gt;TTC2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YG-10A-0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02_029ip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PPP3R1&gt;TTC2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YG-01A-21D-A11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 dirty="0" err="1" smtClean="0">
                          <a:effectLst/>
                          <a:latin typeface="Arial"/>
                        </a:rPr>
                        <a:t>Tumor</a:t>
                      </a:r>
                      <a:endParaRPr lang="fr-FR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effectLst/>
                          <a:latin typeface="Arial"/>
                        </a:rPr>
                        <a:t>H_02_029iq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PPP3R1&gt;TTC2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YG-10A-0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fr-FR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effectLst/>
                          <a:latin typeface="Arial"/>
                        </a:rPr>
                        <a:t>H_02_029iq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NOS1AP&gt;C1orf12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YG-01A-21D-A11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Tumor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01_029iU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NOS1AP&gt;C1orf12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2-A0YG-10A-0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01_029iU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SFMBT2&gt;CELF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8-A07B-01A-1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Tumor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0_029iu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SFMBT2&gt;CELF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8-A07B-10A-0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0_029iu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LAN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LAN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802399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4 </a:t>
            </a:r>
            <a:r>
              <a:rPr lang="en-US" dirty="0" smtClean="0"/>
              <a:t>chr20</a:t>
            </a:r>
            <a:r>
              <a:rPr lang="en-US" dirty="0"/>
              <a:t>:</a:t>
            </a:r>
            <a:r>
              <a:rPr lang="en-US" dirty="0" smtClean="0"/>
              <a:t>33923847 </a:t>
            </a:r>
            <a:r>
              <a:rPr lang="en-US" dirty="0"/>
              <a:t>SK-BR-3 </a:t>
            </a:r>
            <a:r>
              <a:rPr lang="en-US" dirty="0" smtClean="0"/>
              <a:t>breakpoint</a:t>
            </a:r>
            <a:endParaRPr lang="en-US" dirty="0"/>
          </a:p>
        </p:txBody>
      </p:sp>
      <p:pic>
        <p:nvPicPr>
          <p:cNvPr id="3" name="Picture 2" descr="Breakpoint_PHF20_CPNE1_1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33538"/>
            <a:ext cx="9144000" cy="5402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550246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/>
              <a:t>Figure </a:t>
            </a:r>
            <a:r>
              <a:rPr lang="en-US" dirty="0" smtClean="0"/>
              <a:t>S40 </a:t>
            </a:r>
            <a:r>
              <a:rPr lang="en-US" dirty="0"/>
              <a:t>TCGA SV breakpoint validation</a:t>
            </a:r>
          </a:p>
        </p:txBody>
      </p:sp>
      <p:pic>
        <p:nvPicPr>
          <p:cNvPr id="3" name="Picture 2" descr="BRC 3_lonza_060513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9334" y="1519238"/>
            <a:ext cx="3657600" cy="2834640"/>
          </a:xfrm>
          <a:prstGeom prst="rect">
            <a:avLst/>
          </a:prstGeom>
        </p:spPr>
      </p:pic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4238068"/>
              </p:ext>
            </p:extLst>
          </p:nvPr>
        </p:nvGraphicFramePr>
        <p:xfrm>
          <a:off x="931332" y="4353878"/>
          <a:ext cx="6951134" cy="2311400"/>
        </p:xfrm>
        <a:graphic>
          <a:graphicData uri="http://schemas.openxmlformats.org/drawingml/2006/table">
            <a:tbl>
              <a:tblPr/>
              <a:tblGrid>
                <a:gridCol w="799381"/>
                <a:gridCol w="1204863"/>
                <a:gridCol w="2225374"/>
                <a:gridCol w="754051"/>
                <a:gridCol w="927395"/>
                <a:gridCol w="1040070"/>
              </a:tblGrid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it-IT" sz="1000" b="1" i="0" u="none" strike="noStrike">
                          <a:effectLst/>
                          <a:latin typeface="Arial"/>
                        </a:rPr>
                        <a:t>Gel 3 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Gene Fusion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DNA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Tissue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err="1" smtClean="0">
                          <a:effectLst/>
                          <a:latin typeface="Arial"/>
                        </a:rPr>
                        <a:t>Amplicon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Common </a:t>
                      </a:r>
                      <a:r>
                        <a:rPr lang="en-US" sz="1000" b="1" i="0" u="none" strike="noStrike" dirty="0">
                          <a:effectLst/>
                          <a:latin typeface="Arial"/>
                        </a:rPr>
                        <a:t>na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Ladde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NF1&gt;NLE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_LS-A8-A09I-01A-22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/>
                          <a:cs typeface="Arial"/>
                        </a:rPr>
                        <a:t>Tumor</a:t>
                      </a:r>
                      <a:endParaRPr lang="en-US" sz="1000" dirty="0"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C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NF1&gt;NLE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_LS-A8-A09I-10A-01D-A04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/>
                          <a:cs typeface="Arial"/>
                        </a:rPr>
                        <a:t>Normal</a:t>
                      </a:r>
                      <a:endParaRPr lang="en-US" sz="1000" dirty="0"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C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BRC1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NF1&gt;NLE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8-A09I-01A-22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/>
                          <a:cs typeface="Arial"/>
                        </a:rPr>
                        <a:t>Tumor</a:t>
                      </a:r>
                      <a:endParaRPr lang="en-US" sz="1000" dirty="0"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z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NF1&gt;NLE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_LS-A8-A09I-10A-01D-A04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/>
                          <a:cs typeface="Arial"/>
                        </a:rPr>
                        <a:t>Normal</a:t>
                      </a:r>
                      <a:endParaRPr lang="en-US" sz="1000" dirty="0"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z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1000" b="0" i="0" u="none" strike="noStrike">
                          <a:effectLst/>
                          <a:latin typeface="Arial"/>
                        </a:rPr>
                        <a:t>TEX2&gt;uc002iyl.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8-A09I-01A-22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/>
                          <a:cs typeface="Arial"/>
                        </a:rPr>
                        <a:t>Tumor</a:t>
                      </a:r>
                      <a:endParaRPr lang="en-US" sz="1000" dirty="0"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A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1000" b="0" i="0" u="none" strike="noStrike">
                          <a:effectLst/>
                          <a:latin typeface="Arial"/>
                        </a:rPr>
                        <a:t>TEX2&gt;uc002iyl.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8-A09I-10A-01D-A04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/>
                          <a:cs typeface="Arial"/>
                        </a:rPr>
                        <a:t>Normal</a:t>
                      </a:r>
                      <a:endParaRPr lang="en-US" sz="1000" dirty="0"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A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C17orf75&gt;TOP2A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_LS-A8-A09I-01A-22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/>
                          <a:cs typeface="Arial"/>
                        </a:rPr>
                        <a:t>Tumor</a:t>
                      </a:r>
                      <a:endParaRPr lang="en-US" sz="1000" dirty="0"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C17orf75&gt;TOP2A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_LS-A8-A09I-10A-01D-A04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/>
                          <a:cs typeface="Arial"/>
                        </a:rPr>
                        <a:t>Normal</a:t>
                      </a:r>
                      <a:endParaRPr lang="en-US" sz="1000" dirty="0"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DUSP14&gt;EME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_LS-A8-A09I-01A-22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/>
                          <a:cs typeface="Arial"/>
                        </a:rPr>
                        <a:t>Tumor</a:t>
                      </a:r>
                      <a:endParaRPr lang="en-US" sz="1000" dirty="0"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DUSP14&gt;EME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_LS-A8-A09I-10A-01D-A04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/>
                          <a:cs typeface="Arial"/>
                        </a:rPr>
                        <a:t>Normal</a:t>
                      </a:r>
                      <a:endParaRPr lang="en-US" sz="1000" dirty="0"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17_029i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LAN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LAN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04903066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/>
              <a:t>Figure </a:t>
            </a:r>
            <a:r>
              <a:rPr lang="en-US" dirty="0" smtClean="0"/>
              <a:t>S41 </a:t>
            </a:r>
            <a:r>
              <a:rPr lang="en-US" dirty="0"/>
              <a:t>TCGA SV breakpoint validation</a:t>
            </a:r>
          </a:p>
        </p:txBody>
      </p:sp>
      <p:pic>
        <p:nvPicPr>
          <p:cNvPr id="3" name="Picture 2" descr="BRC 4_lonza_060513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4667" y="1517386"/>
            <a:ext cx="3657600" cy="2834640"/>
          </a:xfrm>
          <a:prstGeom prst="rect">
            <a:avLst/>
          </a:prstGeom>
        </p:spPr>
      </p:pic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4745757"/>
              </p:ext>
            </p:extLst>
          </p:nvPr>
        </p:nvGraphicFramePr>
        <p:xfrm>
          <a:off x="956735" y="4352026"/>
          <a:ext cx="6756396" cy="2311400"/>
        </p:xfrm>
        <a:graphic>
          <a:graphicData uri="http://schemas.openxmlformats.org/drawingml/2006/table">
            <a:tbl>
              <a:tblPr/>
              <a:tblGrid>
                <a:gridCol w="825117"/>
                <a:gridCol w="1243656"/>
                <a:gridCol w="2212272"/>
                <a:gridCol w="621153"/>
                <a:gridCol w="804334"/>
                <a:gridCol w="1049864"/>
              </a:tblGrid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it-IT" sz="1000" b="1" i="0" u="none" strike="noStrike">
                          <a:effectLst/>
                          <a:latin typeface="Arial"/>
                        </a:rPr>
                        <a:t>Gel 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Gene Fusion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DNA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Tissue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err="1" smtClean="0">
                          <a:effectLst/>
                          <a:latin typeface="Arial"/>
                        </a:rPr>
                        <a:t>Amplicon</a:t>
                      </a:r>
                      <a:endParaRPr lang="en-US" sz="1000" b="1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/>
                        </a:rPr>
                        <a:t>Common </a:t>
                      </a:r>
                      <a:r>
                        <a:rPr lang="en-US" sz="1000" b="1" i="0" u="none" strike="noStrike" dirty="0">
                          <a:effectLst/>
                          <a:latin typeface="Arial"/>
                        </a:rPr>
                        <a:t>nam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Ladder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ZNRF3&gt;ASCC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8-A094-01A-1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Tumor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22_029iG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ZNRF3&gt;ASCC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8-A094-10A-0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22_029iG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0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ZNF292&gt;FIG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O-A0J2-01A-1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Tumor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06_029i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1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ZNF292&gt;FIG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O-A0J2-10A-01D-A047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/>
                        </a:rPr>
                        <a:t>H_06_029i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1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GPR160&gt;PRKCI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O-A0JM-01A-21X-A073-09-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Tumor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03_029i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1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GPR160&gt;PRKCI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O-A0JM-10A-0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03_029i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1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Well 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LLGL2&gt;CA1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H_LS-AO-A0JM-01A-21X-A073-09-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1000" b="0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Tumor</a:t>
                      </a:r>
                      <a:endParaRPr lang="pl-PL" sz="1000" b="0" i="0" u="none" strike="noStrike" dirty="0">
                        <a:solidFill>
                          <a:srgbClr val="FF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10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H_17_029iw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BRC11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Well 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LLGL2&gt;CA1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AO-A0JM-10A-01D-A19H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1000" b="0" i="0" u="none" strike="noStrike" dirty="0" err="1" smtClean="0">
                          <a:effectLst/>
                          <a:latin typeface="Arial"/>
                        </a:rPr>
                        <a:t>Normal</a:t>
                      </a:r>
                      <a:endParaRPr lang="pl-PL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1000" b="0" i="0" u="none" strike="noStrike">
                          <a:effectLst/>
                          <a:latin typeface="Arial"/>
                        </a:rPr>
                        <a:t>H_17_029iw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11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GGA1&gt;TRIOBP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B6-A0IJ-01A-11D-A045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Tumor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22_029iF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7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GGA1&gt;TRIOBP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LS-B6-A0IJ-10A-01D-A128-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effectLst/>
                          <a:latin typeface="Arial"/>
                        </a:rPr>
                        <a:t>Normal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H_22_029iF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RC7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LAN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Well 1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/>
                        </a:rPr>
                        <a:t>BLANK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cxnSp>
        <p:nvCxnSpPr>
          <p:cNvPr id="6" name="Straight Arrow Connector 5"/>
          <p:cNvCxnSpPr/>
          <p:nvPr/>
        </p:nvCxnSpPr>
        <p:spPr>
          <a:xfrm>
            <a:off x="7281333" y="5765806"/>
            <a:ext cx="431800" cy="1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7713133" y="5304141"/>
            <a:ext cx="1264777" cy="9233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/>
              <a:t>Capillary</a:t>
            </a:r>
          </a:p>
          <a:p>
            <a:r>
              <a:rPr lang="en-US" dirty="0" smtClean="0"/>
              <a:t>Sequencing</a:t>
            </a:r>
          </a:p>
          <a:p>
            <a:r>
              <a:rPr lang="en-US" dirty="0" smtClean="0"/>
              <a:t>confirm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7174592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42 </a:t>
            </a:r>
            <a:r>
              <a:rPr lang="en-US" dirty="0" smtClean="0"/>
              <a:t>breakpoint sequence from capillary sequencing</a:t>
            </a:r>
            <a:endParaRPr lang="en-US" dirty="0"/>
          </a:p>
        </p:txBody>
      </p:sp>
      <p:pic>
        <p:nvPicPr>
          <p:cNvPr id="3" name="Picture 2" descr="TCGA_BRC_LLGL2_CA10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67933"/>
            <a:ext cx="9144000" cy="41552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58815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5 </a:t>
            </a:r>
            <a:r>
              <a:rPr lang="en-US" dirty="0" smtClean="0"/>
              <a:t>chr20</a:t>
            </a:r>
            <a:r>
              <a:rPr lang="en-US" dirty="0"/>
              <a:t>:</a:t>
            </a:r>
            <a:r>
              <a:rPr lang="en-US" dirty="0" smtClean="0"/>
              <a:t>33679982 </a:t>
            </a:r>
            <a:r>
              <a:rPr lang="en-US" dirty="0"/>
              <a:t>SK-BR-3 </a:t>
            </a:r>
            <a:r>
              <a:rPr lang="en-US" dirty="0" smtClean="0"/>
              <a:t>breakpoint </a:t>
            </a:r>
            <a:endParaRPr lang="en-US" dirty="0"/>
          </a:p>
        </p:txBody>
      </p:sp>
      <p:pic>
        <p:nvPicPr>
          <p:cNvPr id="3" name="Picture 2" descr="Breakpoint_PHF20_CPNE1_2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52588"/>
            <a:ext cx="9144000" cy="5402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74212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6 </a:t>
            </a:r>
            <a:r>
              <a:rPr lang="en-US" dirty="0" smtClean="0"/>
              <a:t>chr8</a:t>
            </a:r>
            <a:r>
              <a:rPr lang="en-US" dirty="0"/>
              <a:t>:</a:t>
            </a:r>
            <a:r>
              <a:rPr lang="en-US" dirty="0" smtClean="0"/>
              <a:t>121547851 </a:t>
            </a:r>
            <a:r>
              <a:rPr lang="en-US" dirty="0"/>
              <a:t>SK-BR-3 </a:t>
            </a:r>
            <a:r>
              <a:rPr lang="en-US" dirty="0" smtClean="0"/>
              <a:t>breakpoint </a:t>
            </a:r>
            <a:endParaRPr lang="en-US" dirty="0"/>
          </a:p>
        </p:txBody>
      </p:sp>
      <p:pic>
        <p:nvPicPr>
          <p:cNvPr id="3" name="Picture 2" descr="Breakpoint_MTBP_SAMD12_1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88584"/>
            <a:ext cx="9144000" cy="5402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558464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7 </a:t>
            </a:r>
            <a:r>
              <a:rPr lang="en-US" dirty="0" smtClean="0"/>
              <a:t>chr8:119503797 </a:t>
            </a:r>
            <a:r>
              <a:rPr lang="en-US" dirty="0"/>
              <a:t>SK-BR-3 </a:t>
            </a:r>
            <a:r>
              <a:rPr lang="en-US" dirty="0" smtClean="0"/>
              <a:t>breakpoint</a:t>
            </a:r>
            <a:endParaRPr lang="en-US" dirty="0"/>
          </a:p>
        </p:txBody>
      </p:sp>
      <p:pic>
        <p:nvPicPr>
          <p:cNvPr id="3" name="Picture 2" descr="Breakpoint_MTBP_SAMD12_2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58950"/>
            <a:ext cx="9144000" cy="5402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848860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8 </a:t>
            </a:r>
            <a:r>
              <a:rPr lang="en-US" dirty="0" smtClean="0"/>
              <a:t>chr8</a:t>
            </a:r>
            <a:r>
              <a:rPr lang="en-US" dirty="0"/>
              <a:t>:</a:t>
            </a:r>
            <a:r>
              <a:rPr lang="en-US" dirty="0" smtClean="0"/>
              <a:t>119662603 </a:t>
            </a:r>
            <a:r>
              <a:rPr lang="en-US" dirty="0"/>
              <a:t>SK-BR-3 </a:t>
            </a:r>
            <a:r>
              <a:rPr lang="en-US" dirty="0" smtClean="0"/>
              <a:t>breakpoint</a:t>
            </a:r>
            <a:endParaRPr lang="en-US" dirty="0"/>
          </a:p>
        </p:txBody>
      </p:sp>
      <p:pic>
        <p:nvPicPr>
          <p:cNvPr id="3" name="Picture 2" descr="Breakpoint_MTBP_SAMD12_3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61067"/>
            <a:ext cx="9144000" cy="5402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257571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9 </a:t>
            </a:r>
            <a:r>
              <a:rPr lang="en-US" dirty="0" smtClean="0"/>
              <a:t>chr8</a:t>
            </a:r>
            <a:r>
              <a:rPr lang="en-US" dirty="0"/>
              <a:t>:</a:t>
            </a:r>
            <a:r>
              <a:rPr lang="en-US" dirty="0" smtClean="0"/>
              <a:t>118985543 </a:t>
            </a:r>
            <a:r>
              <a:rPr lang="en-US" dirty="0"/>
              <a:t>SK-BR-3 </a:t>
            </a:r>
            <a:r>
              <a:rPr lang="en-US" dirty="0" smtClean="0"/>
              <a:t>breakpoint</a:t>
            </a:r>
            <a:endParaRPr lang="en-US" dirty="0"/>
          </a:p>
        </p:txBody>
      </p:sp>
      <p:pic>
        <p:nvPicPr>
          <p:cNvPr id="3" name="Picture 2" descr="Breakpoint_MTBP_SAMD12_4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47838"/>
            <a:ext cx="9144000" cy="52705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95135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74</TotalTime>
  <Words>1473</Words>
  <Application>Microsoft Macintosh PowerPoint</Application>
  <PresentationFormat>On-screen Show (4:3)</PresentationFormat>
  <Paragraphs>406</Paragraphs>
  <Slides>4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2</vt:i4>
      </vt:variant>
    </vt:vector>
  </HeadingPairs>
  <TitlesOfParts>
    <vt:vector size="43" baseType="lpstr">
      <vt:lpstr>Office Theme</vt:lpstr>
      <vt:lpstr> Figure S1  PREX1-CPNE1 gene fusion in SK-BR-3</vt:lpstr>
      <vt:lpstr> Figure S2 chr20:46795673 SK-BR-3 breakpoint</vt:lpstr>
      <vt:lpstr> Figure S3 chr20:33925625 SK-BR-3 breakpoint</vt:lpstr>
      <vt:lpstr> Figure S4 chr20:33923847 SK-BR-3 breakpoint</vt:lpstr>
      <vt:lpstr> Figure S5 chr20:33679982 SK-BR-3 breakpoint </vt:lpstr>
      <vt:lpstr> Figure S6 chr8:121547851 SK-BR-3 breakpoint </vt:lpstr>
      <vt:lpstr> Figure S7 chr8:119503797 SK-BR-3 breakpoint</vt:lpstr>
      <vt:lpstr> Figure S8 chr8:119662603 SK-BR-3 breakpoint</vt:lpstr>
      <vt:lpstr> Figure S9 chr8:118985543 SK-BR-3 breakpoint</vt:lpstr>
      <vt:lpstr> Figure S10 chr8:124171162 SK-BR-3 breakpoint</vt:lpstr>
      <vt:lpstr> Figure S11 chr8:81916434 SK-BR-3 breakpoint</vt:lpstr>
      <vt:lpstr> Figure S12 A09I copy number alteration</vt:lpstr>
      <vt:lpstr> Figure S13  NF1-NLE1 gene fusion in A09I</vt:lpstr>
      <vt:lpstr> Figure S14  A09I Chr17 copy number alteration</vt:lpstr>
      <vt:lpstr> Figure S15 chr17:29506430 A09I breakpoint</vt:lpstr>
      <vt:lpstr> Figure S16 chr17:50072973 A09I breakpoint</vt:lpstr>
      <vt:lpstr> Figure S17 chr17:50074020 A09I breakpoint</vt:lpstr>
      <vt:lpstr> Figure S18 chr17:33464306 A09I breakpoint</vt:lpstr>
      <vt:lpstr> Figure S19  PPP1R1B-PIPOX fusion in A0D1</vt:lpstr>
      <vt:lpstr> Figure S20 A0D1 copy number alteration</vt:lpstr>
      <vt:lpstr> Figure S21 A0D1 chr17 copy number alteration</vt:lpstr>
      <vt:lpstr> Figure S22 chr17:37792878 A0D1 breakpoint</vt:lpstr>
      <vt:lpstr> Figure S23 chr17:37792543 A0D1 breakpoint</vt:lpstr>
      <vt:lpstr> Figure S24 chr17:37792543 A0D1 breakpoint</vt:lpstr>
      <vt:lpstr> Figure S25 chr17:26168287 A0D1 breakpoint</vt:lpstr>
      <vt:lpstr> Figure S26 chr17:26171328 A0D1 breakpoint</vt:lpstr>
      <vt:lpstr> Figure S27 chr17:27378219 A0D1 breakpoint</vt:lpstr>
      <vt:lpstr> Figure S28  PPP3R1-TTC27 fusion in A0YG</vt:lpstr>
      <vt:lpstr> Figure S29 A0YG copy number alteration</vt:lpstr>
      <vt:lpstr> Figure S30 A0YG Chr2 chromothripsis</vt:lpstr>
      <vt:lpstr> Figure S31 PPP3R1-TTC27 chromothripsis fusion</vt:lpstr>
      <vt:lpstr> Figure S32 chr2:68474379 A0YG breakpoint</vt:lpstr>
      <vt:lpstr> Figure S33 chr2:61696395 A0YG breakpoint</vt:lpstr>
      <vt:lpstr> Figure S34 chr2:61648297 A0YG breakpoint</vt:lpstr>
      <vt:lpstr> Figure S35 chr2:33525486 A0YG breakpoint</vt:lpstr>
      <vt:lpstr> Figure S36 chr2:33483602 A0YG breakpoint</vt:lpstr>
      <vt:lpstr> Figure S37 chr2:33006736 A0YG breakpoint</vt:lpstr>
      <vt:lpstr> Figure S38 TCGA SV breakpoint validation</vt:lpstr>
      <vt:lpstr> Figure S39 TCGA SV breakpoint validation</vt:lpstr>
      <vt:lpstr> Figure S40 TCGA SV breakpoint validation</vt:lpstr>
      <vt:lpstr> Figure S41 TCGA SV breakpoint validation</vt:lpstr>
      <vt:lpstr> Figure S42 breakpoint sequence from capillary sequencing</vt:lpstr>
    </vt:vector>
  </TitlesOfParts>
  <Company>MDAC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 Chen</dc:creator>
  <cp:lastModifiedBy>Ken Chen</cp:lastModifiedBy>
  <cp:revision>60</cp:revision>
  <dcterms:created xsi:type="dcterms:W3CDTF">2013-02-12T04:35:45Z</dcterms:created>
  <dcterms:modified xsi:type="dcterms:W3CDTF">2013-08-20T21:08:54Z</dcterms:modified>
</cp:coreProperties>
</file>